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21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8F3359-507E-470E-B801-4768109DB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81E68B4-F6E5-4AB1-950C-BFCF81B541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C8DC45-21F0-4460-9EE4-B02AB0EE8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10B24F-1A6C-4C32-9370-9E29D9B9F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39AB36-C4AF-4C8F-91C8-C13A1E906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234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38066A-3F83-43E1-8A44-99C35C9889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2371222-70F5-4D16-B3C0-3125C2E391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31EC90-4F2C-43F9-9C63-85C333C6F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0E46DB-6537-4434-BEF5-FB584698A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0D09D0-E17C-4E1B-B89B-71327F3BC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021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459D732-802F-4A81-B2B0-0694B3E4C6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205ABF-B3F3-4E5E-85C2-78C9756222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777C40-63F3-4853-A5F9-725514395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F459F9-9EB9-48F2-AACC-C7141E2D7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83032F-D7F8-44CB-A152-9B34873E1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0051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FFE8ED-FB5D-43B2-A581-8F3B82C43B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2D3498-C3F3-4E8C-95EB-C4F728025A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57AB17-848C-4BF3-8181-6171E76E3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7BCD42-5435-4C68-8635-6EFAC5B00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D68D40-6F2F-47D1-8A8F-54EECE3FF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168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2825E2-9C46-4E5D-928E-2BC9EF78D3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A68D94-C43C-48EB-8002-2E7D782478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FCAD67-8299-467B-80FC-61E4CF7D9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5D4CAC-71DA-48FE-8498-24A84E4D8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38D05A-EF30-4138-BAF9-E2236E6D5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999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F2C669-AD6A-4200-B322-8090113EBC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7FA41F-7D9E-4FBB-90D2-9EDA077C56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FE76D87-3D2F-4BAC-8DB7-CB1FF58DB0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C225B9A-8928-48FE-9ACB-4427020DD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C6950D-E248-4967-A5FF-CE1FF3C6D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0AC224-5B0E-401C-AD56-2F4C05021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6686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5200BD-FAF5-4D16-9049-530189EC1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389B083-AA18-4208-89DD-AE77520F9E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637536D-A21B-42A0-87AC-8B65A7987D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DD157B-2BE4-4DFA-A140-0D0426888C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6B1500D-DA53-4929-ADC7-9A4B1EB49D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A2FC2A3-FBC2-4218-B458-33B63F80C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0729921-1AB6-46A0-91F2-C13ABBED0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8455E59-043F-44EB-A4D8-83580430C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196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EF5F99-C216-46BC-BF63-9042C0FB8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BC1197A-FE65-495F-8862-D97CB0044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EA053B2-B1BC-449E-84D4-B28E25D49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9046A96-9C50-4E15-B885-80D6B3CA7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1284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82419CF-18C3-4487-BCBE-20A4D85C5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DB0F0D4-25AF-4BD9-A1C0-5B90C67EF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D4BB717-3196-4DD1-8F5D-754CB3434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993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9B3C4F-FC4C-4AD1-99A4-3BCF3B15A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5A870C-6CEA-4750-893D-155B334359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70F7ED-4662-4412-9E07-95E1436510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69800D8-0821-4F81-A378-A48912257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5F3E36-C37E-473A-9BD3-E70BC8B0D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C574BEC-DCC6-4252-9DFD-01CA9276F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06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D7D252-7A3B-459B-B52B-E1D7EDBC4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513C1AC-69C3-44CE-B032-30C3491A79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3C8B79-AF80-4EB7-875A-E8567DE8D3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21944A-6298-45FB-9477-619BCBEB3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1900DE-DF87-4EFF-83A6-86897CC03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EBC7AA-9D88-4DBB-B67B-27784DDCC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826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8752E32-E745-4049-946A-D16C64442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48AF6C2-C282-438F-B435-A9D5E4D19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4F57E3-3D43-4F74-A409-4EA1669DC5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DCEAD-A3EF-400D-A38F-569337239F6C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76C476-A45B-4660-8F2F-A9B2EA3339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48A5D7-4D94-4649-BCA1-C52D7B9934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546EB-EF15-422E-8E47-EF6B5C7654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8678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6C52DF8-82E0-483C-94B8-4670368F6807}"/>
              </a:ext>
            </a:extLst>
          </p:cNvPr>
          <p:cNvSpPr txBox="1"/>
          <p:nvPr/>
        </p:nvSpPr>
        <p:spPr>
          <a:xfrm>
            <a:off x="166665" y="162160"/>
            <a:ext cx="72362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igure 1. </a:t>
            </a:r>
            <a:r>
              <a:rPr lang="en-US" altLang="zh-CN" sz="1400" dirty="0"/>
              <a:t>Consistency between the direct and indirect comparisons for disease-free survival</a:t>
            </a:r>
            <a:endParaRPr lang="zh-CN" altLang="en-US" sz="14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0015DF8-6EA7-4ED5-A38D-D9090A38CB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4560" y="1138783"/>
            <a:ext cx="7382879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7651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511C12C1-A424-4F27-A5C5-65F260B08D09}"/>
              </a:ext>
            </a:extLst>
          </p:cNvPr>
          <p:cNvSpPr txBox="1"/>
          <p:nvPr/>
        </p:nvSpPr>
        <p:spPr>
          <a:xfrm>
            <a:off x="166665" y="162160"/>
            <a:ext cx="67505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igure 2. </a:t>
            </a:r>
            <a:r>
              <a:rPr lang="en-US" altLang="zh-CN" sz="1400" dirty="0"/>
              <a:t>Consistency between the direct and indirect comparisons for overall survival</a:t>
            </a:r>
            <a:endParaRPr lang="zh-CN" altLang="en-US" sz="140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BD5F751-6C6E-490A-9CAB-D776C0691E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3996" y="1138783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4095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1</TotalTime>
  <Words>26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毓文</dc:creator>
  <cp:lastModifiedBy>毓文</cp:lastModifiedBy>
  <cp:revision>7</cp:revision>
  <dcterms:created xsi:type="dcterms:W3CDTF">2022-01-16T08:45:05Z</dcterms:created>
  <dcterms:modified xsi:type="dcterms:W3CDTF">2022-02-04T11:19:44Z</dcterms:modified>
</cp:coreProperties>
</file>